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258" r:id="rId4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jl, gemiddeld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7" autoAdjust="0"/>
    <p:restoredTop sz="94660"/>
  </p:normalViewPr>
  <p:slideViewPr>
    <p:cSldViewPr snapToGrid="0">
      <p:cViewPr varScale="1">
        <p:scale>
          <a:sx n="88" d="100"/>
          <a:sy n="88" d="100"/>
        </p:scale>
        <p:origin x="26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 smtClean="0"/>
              <a:t>Klik om de ondertitelstijl van het mod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167991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8929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6270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7665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51879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06971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432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966252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62790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202970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 smtClean="0"/>
              <a:t>Tekststijl van het model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96395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Tekststijl van het model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5F4392-6CAF-4E98-8251-57C785D71E2C}" type="datetimeFigureOut">
              <a:rPr lang="nl-NL" smtClean="0"/>
              <a:t>28-11-2023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706EF-893C-47AE-9F34-2D86E10DE3C2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94494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067024"/>
              </p:ext>
            </p:extLst>
          </p:nvPr>
        </p:nvGraphicFramePr>
        <p:xfrm>
          <a:off x="1279160" y="1686279"/>
          <a:ext cx="8422190" cy="2511426"/>
        </p:xfrm>
        <a:graphic>
          <a:graphicData uri="http://schemas.openxmlformats.org/drawingml/2006/table">
            <a:tbl>
              <a:tblPr firstRow="1" firstCol="1" bandRow="1">
                <a:tableStyleId>{073A0DAA-6AF3-43AB-8588-CEC1D06C72B9}</a:tableStyleId>
              </a:tblPr>
              <a:tblGrid>
                <a:gridCol w="2391327">
                  <a:extLst>
                    <a:ext uri="{9D8B030D-6E8A-4147-A177-3AD203B41FA5}">
                      <a16:colId xmlns:a16="http://schemas.microsoft.com/office/drawing/2014/main" val="2370012559"/>
                    </a:ext>
                  </a:extLst>
                </a:gridCol>
                <a:gridCol w="1402741">
                  <a:extLst>
                    <a:ext uri="{9D8B030D-6E8A-4147-A177-3AD203B41FA5}">
                      <a16:colId xmlns:a16="http://schemas.microsoft.com/office/drawing/2014/main" val="128526263"/>
                    </a:ext>
                  </a:extLst>
                </a:gridCol>
                <a:gridCol w="4628122">
                  <a:extLst>
                    <a:ext uri="{9D8B030D-6E8A-4147-A177-3AD203B41FA5}">
                      <a16:colId xmlns:a16="http://schemas.microsoft.com/office/drawing/2014/main" val="58106781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Platform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Manufacturers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</a:rPr>
                        <a:t>Nucleic Acid Amplification Test</a:t>
                      </a:r>
                      <a:endParaRPr lang="nl-NL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189613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100" b="0" dirty="0">
                          <a:solidFill>
                            <a:schemeClr val="tx1"/>
                          </a:solidFill>
                          <a:effectLst/>
                        </a:rPr>
                        <a:t>- </a:t>
                      </a:r>
                      <a:r>
                        <a:rPr lang="nl-NL" sz="1100" b="0" dirty="0" err="1">
                          <a:solidFill>
                            <a:schemeClr val="tx1"/>
                          </a:solidFill>
                          <a:effectLst/>
                        </a:rPr>
                        <a:t>MagNA</a:t>
                      </a:r>
                      <a:r>
                        <a:rPr lang="nl-NL" sz="1100" b="0" dirty="0">
                          <a:solidFill>
                            <a:schemeClr val="tx1"/>
                          </a:solidFill>
                          <a:effectLst/>
                        </a:rPr>
                        <a:t> Pure 96 (DNA/RNA </a:t>
                      </a:r>
                      <a:r>
                        <a:rPr lang="nl-NL" sz="1100" b="0" dirty="0" err="1">
                          <a:solidFill>
                            <a:schemeClr val="tx1"/>
                          </a:solidFill>
                          <a:effectLst/>
                        </a:rPr>
                        <a:t>isolation</a:t>
                      </a:r>
                      <a:r>
                        <a:rPr lang="nl-NL" sz="1100" b="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- ABI Prism 7500 (real time PCR)</a:t>
                      </a:r>
                      <a:endParaRPr lang="nl-NL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Roche</a:t>
                      </a:r>
                      <a:endParaRPr lang="nl-NL" sz="1100" b="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Applied </a:t>
                      </a:r>
                      <a:r>
                        <a:rPr lang="en-US" sz="1100" b="0" dirty="0" err="1">
                          <a:solidFill>
                            <a:schemeClr val="tx1"/>
                          </a:solidFill>
                          <a:effectLst/>
                        </a:rPr>
                        <a:t>Biosystems</a:t>
                      </a:r>
                      <a:endParaRPr lang="nl-NL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LDT: Influenza A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effectLst/>
                        </a:rPr>
                        <a:t>a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, Influenza B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effectLst/>
                        </a:rPr>
                        <a:t>a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, RSV-A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, RSV-B</a:t>
                      </a:r>
                      <a:r>
                        <a:rPr lang="en-US" sz="1100" baseline="30000" dirty="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, 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hMPV</a:t>
                      </a:r>
                      <a:r>
                        <a:rPr lang="en-US" sz="1100" baseline="30000" dirty="0" err="1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 and 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rhinovirus</a:t>
                      </a:r>
                      <a:r>
                        <a:rPr lang="en-US" sz="1100" baseline="30000" dirty="0" err="1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0777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- Panther Fusion</a:t>
                      </a:r>
                      <a:endParaRPr lang="nl-NL" sz="1100" b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nl-NL" sz="1100" b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nl-NL" sz="1100" b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nl-NL" sz="1100" b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- Panther</a:t>
                      </a:r>
                      <a:endParaRPr lang="nl-NL" sz="11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Hologic</a:t>
                      </a:r>
                      <a:endParaRPr lang="nl-NL" sz="11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Panther Fusion™ Flu A/B/RSV Assay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Panther Fusion™ 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AdV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/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hMPV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/RV Assay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LDT: SARS-CoV-2 Open 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Access</a:t>
                      </a:r>
                      <a:r>
                        <a:rPr lang="en-US" sz="1100" baseline="30000" dirty="0" err="1">
                          <a:solidFill>
                            <a:schemeClr val="tx1"/>
                          </a:solidFill>
                          <a:effectLst/>
                        </a:rPr>
                        <a:t>e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Aptima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® SARS-CoV-2 Assay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28985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 err="1">
                          <a:solidFill>
                            <a:schemeClr val="tx1"/>
                          </a:solidFill>
                          <a:effectLst/>
                        </a:rPr>
                        <a:t>GeneXpert</a:t>
                      </a:r>
                      <a:endParaRPr lang="nl-NL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>
                          <a:solidFill>
                            <a:schemeClr val="tx1"/>
                          </a:solidFill>
                          <a:effectLst/>
                        </a:rPr>
                        <a:t>Cepheid</a:t>
                      </a:r>
                      <a:endParaRPr lang="nl-NL" sz="11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Xpert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® Xpress SARS-CoV-2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Xpert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® Xpress SARS-CoV-2 Plus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Xpert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® Xpress SARS-CoV-2/Flu/RSV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Xpert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® Xpress SARS-CoV-2/Flu/RSV Plus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81287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 err="1">
                          <a:solidFill>
                            <a:schemeClr val="tx1"/>
                          </a:solidFill>
                          <a:effectLst/>
                        </a:rPr>
                        <a:t>Cobas</a:t>
                      </a: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1100" b="0" dirty="0" err="1">
                          <a:solidFill>
                            <a:schemeClr val="tx1"/>
                          </a:solidFill>
                          <a:effectLst/>
                        </a:rPr>
                        <a:t>Liat</a:t>
                      </a:r>
                      <a:endParaRPr lang="nl-NL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b="0" dirty="0">
                          <a:solidFill>
                            <a:schemeClr val="tx1"/>
                          </a:solidFill>
                          <a:effectLst/>
                        </a:rPr>
                        <a:t>Roche</a:t>
                      </a:r>
                      <a:endParaRPr lang="nl-NL" sz="11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Liat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 SARS-CoV-2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solidFill>
                            <a:schemeClr val="tx1"/>
                          </a:solidFill>
                          <a:effectLst/>
                        </a:rPr>
                        <a:t>Liat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</a:rPr>
                        <a:t> SARS-CoV-2/Flu</a:t>
                      </a:r>
                      <a:endParaRPr lang="nl-NL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117298"/>
                  </a:ext>
                </a:extLst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1209693" y="4197705"/>
            <a:ext cx="8024954" cy="430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DT: Lab developed test</a:t>
            </a:r>
            <a:br>
              <a:rPr kumimoji="0" lang="en-US" altLang="nl-NL" sz="11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kumimoji="0" lang="en-US" altLang="nl-NL" sz="1100" b="0" i="0" u="none" strike="noStrike" cap="none" normalizeH="0" baseline="3000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tocol from Erasmus MC (Rotterdam, the Netherlands), </a:t>
            </a:r>
            <a:r>
              <a:rPr kumimoji="0" lang="en-US" altLang="nl-NL" sz="1100" b="0" i="0" u="none" strike="noStrike" cap="none" normalizeH="0" baseline="3000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 </a:t>
            </a: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published PCR design, </a:t>
            </a:r>
            <a:r>
              <a:rPr kumimoji="0" lang="en-US" altLang="nl-NL" sz="1100" b="0" i="0" u="none" strike="noStrike" cap="none" normalizeH="0" baseline="3000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 </a:t>
            </a: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[37], </a:t>
            </a:r>
            <a:r>
              <a:rPr kumimoji="0" lang="en-US" altLang="nl-NL" sz="1100" b="0" i="0" u="none" strike="noStrike" cap="none" normalizeH="0" baseline="30000" dirty="0" err="1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kumimoji="0" lang="en-US" altLang="nl-NL" sz="1100" b="0" i="0" u="none" strike="noStrike" cap="none" normalizeH="0" baseline="0" dirty="0" err="1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published</a:t>
            </a: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CR design,</a:t>
            </a:r>
            <a:r>
              <a:rPr kumimoji="0" lang="en-US" altLang="nl-NL" sz="1100" b="0" i="0" u="none" strike="noStrike" cap="none" normalizeH="0" baseline="3000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 </a:t>
            </a:r>
            <a:r>
              <a:rPr kumimoji="0" lang="en-US" altLang="nl-NL" sz="1100" b="0" i="0" u="none" strike="noStrike" cap="none" normalizeH="0" baseline="0" dirty="0" smtClean="0">
                <a:ln>
                  <a:noFill/>
                </a:ln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apted from [38]</a:t>
            </a:r>
            <a:endParaRPr kumimoji="0" lang="en-US" altLang="nl-NL" sz="1800" b="0" i="0" u="none" strike="noStrike" cap="none" normalizeH="0" baseline="0" dirty="0" smtClean="0">
              <a:ln>
                <a:noFill/>
              </a:ln>
              <a:effectLst/>
              <a:latin typeface="Arial" panose="020B0604020202020204" pitchFamily="34" charset="0"/>
            </a:endParaRPr>
          </a:p>
        </p:txBody>
      </p:sp>
      <p:sp>
        <p:nvSpPr>
          <p:cNvPr id="5" name="Rechthoek 4"/>
          <p:cNvSpPr/>
          <p:nvPr/>
        </p:nvSpPr>
        <p:spPr>
          <a:xfrm>
            <a:off x="1279160" y="778772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nl-NL" b="1" dirty="0" err="1"/>
              <a:t>Table</a:t>
            </a:r>
            <a:r>
              <a:rPr lang="nl-NL" b="1" dirty="0"/>
              <a:t> </a:t>
            </a:r>
            <a:r>
              <a:rPr lang="en-US" altLang="nl-NL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. </a:t>
            </a:r>
            <a:r>
              <a:rPr lang="en-US" altLang="nl-NL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latforms and manufacturers of </a:t>
            </a:r>
            <a:r>
              <a:rPr lang="en-US" altLang="nl-NL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AAT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4404856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hoek 3"/>
          <p:cNvSpPr/>
          <p:nvPr/>
        </p:nvSpPr>
        <p:spPr>
          <a:xfrm>
            <a:off x="1279160" y="778772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nl-NL" b="1" dirty="0" err="1"/>
              <a:t>Table</a:t>
            </a:r>
            <a:r>
              <a:rPr lang="nl-NL" b="1" dirty="0"/>
              <a:t> </a:t>
            </a:r>
            <a:r>
              <a:rPr lang="nl-NL" b="1" dirty="0" smtClean="0"/>
              <a:t>S2.</a:t>
            </a:r>
            <a:r>
              <a:rPr lang="nl-NL" dirty="0" smtClean="0"/>
              <a:t> </a:t>
            </a:r>
            <a:r>
              <a:rPr lang="en-US" dirty="0"/>
              <a:t>Co-infections excluded from analysis</a:t>
            </a:r>
            <a:endParaRPr lang="nl-NL" dirty="0"/>
          </a:p>
        </p:txBody>
      </p:sp>
      <p:graphicFrame>
        <p:nvGraphicFramePr>
          <p:cNvPr id="6" name="Tabel 5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4005206297"/>
              </p:ext>
            </p:extLst>
          </p:nvPr>
        </p:nvGraphicFramePr>
        <p:xfrm>
          <a:off x="1279160" y="1397373"/>
          <a:ext cx="5704114" cy="227764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4106961">
                  <a:extLst>
                    <a:ext uri="{9D8B030D-6E8A-4147-A177-3AD203B41FA5}">
                      <a16:colId xmlns:a16="http://schemas.microsoft.com/office/drawing/2014/main" val="3766248399"/>
                    </a:ext>
                  </a:extLst>
                </a:gridCol>
                <a:gridCol w="1597153">
                  <a:extLst>
                    <a:ext uri="{9D8B030D-6E8A-4147-A177-3AD203B41FA5}">
                      <a16:colId xmlns:a16="http://schemas.microsoft.com/office/drawing/2014/main" val="2855261870"/>
                    </a:ext>
                  </a:extLst>
                </a:gridCol>
              </a:tblGrid>
              <a:tr h="368873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</a:rPr>
                        <a:t>Combination of viruses</a:t>
                      </a:r>
                      <a:endParaRPr lang="nl-NL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</a:rPr>
                        <a:t>number</a:t>
                      </a:r>
                      <a:endParaRPr lang="nl-NL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5327793"/>
                  </a:ext>
                </a:extLst>
              </a:tr>
              <a:tr h="311977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fluenzavirus A </a:t>
                      </a: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influenzavirus B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3490190"/>
                  </a:ext>
                </a:extLst>
              </a:tr>
              <a:tr h="26613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fluenzavirus A </a:t>
                      </a: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SV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1946139"/>
                  </a:ext>
                </a:extLst>
              </a:tr>
              <a:tr h="26613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fluenzavirus A </a:t>
                      </a: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PV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1607421"/>
                  </a:ext>
                </a:extLst>
              </a:tr>
              <a:tr h="26613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fluenzavirus A </a:t>
                      </a: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hinovirus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1004172"/>
                  </a:ext>
                </a:extLst>
              </a:tr>
              <a:tr h="26613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fluenzavirus</a:t>
                      </a:r>
                      <a:r>
                        <a:rPr lang="nl-NL" sz="1400" b="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B </a:t>
                      </a:r>
                      <a:r>
                        <a:rPr lang="nl-NL" sz="1400" b="0" baseline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nl-NL" sz="1400" b="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l-NL" sz="1400" b="0" baseline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PV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3493488"/>
                  </a:ext>
                </a:extLst>
              </a:tr>
              <a:tr h="26613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PV</a:t>
                      </a:r>
                      <a:r>
                        <a:rPr lang="nl-NL" sz="1400" b="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l-NL" sz="1400" b="0" baseline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nl-NL" sz="1400" b="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RSV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6035940"/>
                  </a:ext>
                </a:extLst>
              </a:tr>
              <a:tr h="266132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MPV</a:t>
                      </a: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nl-NL" sz="1400" b="0" dirty="0" err="1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hinovirus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l-NL" sz="1400" b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nl-NL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134727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46540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 3"/>
          <p:cNvGraphicFramePr>
            <a:graphicFrameLocks noGrp="1" noChangeAspect="1"/>
          </p:cNvGraphicFramePr>
          <p:nvPr>
            <p:extLst/>
          </p:nvPr>
        </p:nvGraphicFramePr>
        <p:xfrm>
          <a:off x="144094" y="385841"/>
          <a:ext cx="11882096" cy="5889115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418745">
                  <a:extLst>
                    <a:ext uri="{9D8B030D-6E8A-4147-A177-3AD203B41FA5}">
                      <a16:colId xmlns:a16="http://schemas.microsoft.com/office/drawing/2014/main" val="3766248399"/>
                    </a:ext>
                  </a:extLst>
                </a:gridCol>
                <a:gridCol w="1180076">
                  <a:extLst>
                    <a:ext uri="{9D8B030D-6E8A-4147-A177-3AD203B41FA5}">
                      <a16:colId xmlns:a16="http://schemas.microsoft.com/office/drawing/2014/main" val="3393232553"/>
                    </a:ext>
                  </a:extLst>
                </a:gridCol>
                <a:gridCol w="1180076">
                  <a:extLst>
                    <a:ext uri="{9D8B030D-6E8A-4147-A177-3AD203B41FA5}">
                      <a16:colId xmlns:a16="http://schemas.microsoft.com/office/drawing/2014/main" val="4057550787"/>
                    </a:ext>
                  </a:extLst>
                </a:gridCol>
                <a:gridCol w="1180076">
                  <a:extLst>
                    <a:ext uri="{9D8B030D-6E8A-4147-A177-3AD203B41FA5}">
                      <a16:colId xmlns:a16="http://schemas.microsoft.com/office/drawing/2014/main" val="536948452"/>
                    </a:ext>
                  </a:extLst>
                </a:gridCol>
                <a:gridCol w="1180076">
                  <a:extLst>
                    <a:ext uri="{9D8B030D-6E8A-4147-A177-3AD203B41FA5}">
                      <a16:colId xmlns:a16="http://schemas.microsoft.com/office/drawing/2014/main" val="3568287585"/>
                    </a:ext>
                  </a:extLst>
                </a:gridCol>
                <a:gridCol w="1180076">
                  <a:extLst>
                    <a:ext uri="{9D8B030D-6E8A-4147-A177-3AD203B41FA5}">
                      <a16:colId xmlns:a16="http://schemas.microsoft.com/office/drawing/2014/main" val="1922860353"/>
                    </a:ext>
                  </a:extLst>
                </a:gridCol>
                <a:gridCol w="1180076">
                  <a:extLst>
                    <a:ext uri="{9D8B030D-6E8A-4147-A177-3AD203B41FA5}">
                      <a16:colId xmlns:a16="http://schemas.microsoft.com/office/drawing/2014/main" val="2946371220"/>
                    </a:ext>
                  </a:extLst>
                </a:gridCol>
                <a:gridCol w="1180076">
                  <a:extLst>
                    <a:ext uri="{9D8B030D-6E8A-4147-A177-3AD203B41FA5}">
                      <a16:colId xmlns:a16="http://schemas.microsoft.com/office/drawing/2014/main" val="499001595"/>
                    </a:ext>
                  </a:extLst>
                </a:gridCol>
                <a:gridCol w="1202819">
                  <a:extLst>
                    <a:ext uri="{9D8B030D-6E8A-4147-A177-3AD203B41FA5}">
                      <a16:colId xmlns:a16="http://schemas.microsoft.com/office/drawing/2014/main" val="2844413658"/>
                    </a:ext>
                  </a:extLst>
                </a:gridCol>
              </a:tblGrid>
              <a:tr h="332202"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Model:</a:t>
                      </a:r>
                    </a:p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Mortality SARS-CoV-2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per half year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nl-NL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Model:</a:t>
                      </a:r>
                    </a:p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Mortality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other viruses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5327793"/>
                  </a:ext>
                </a:extLst>
              </a:tr>
              <a:tr h="280963"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Crude OR</a:t>
                      </a:r>
                      <a:endParaRPr lang="nl-NL" sz="800" b="1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p-value</a:t>
                      </a:r>
                      <a:endParaRPr lang="nl-NL" sz="800" b="1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Adjusted</a:t>
                      </a:r>
                      <a:r>
                        <a:rPr lang="en-US" sz="800" b="1" baseline="0" dirty="0" smtClean="0">
                          <a:latin typeface="+mn-lt"/>
                        </a:rPr>
                        <a:t> OR</a:t>
                      </a:r>
                      <a:endParaRPr lang="nl-NL" sz="800" b="1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p-value</a:t>
                      </a:r>
                      <a:endParaRPr lang="nl-NL" sz="800" b="1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Crude OR</a:t>
                      </a:r>
                      <a:endParaRPr lang="nl-NL" sz="800" b="1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p-value</a:t>
                      </a:r>
                      <a:endParaRPr lang="nl-NL" sz="800" b="1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Adjusted</a:t>
                      </a:r>
                      <a:r>
                        <a:rPr lang="en-US" sz="800" b="1" baseline="0" dirty="0" smtClean="0">
                          <a:latin typeface="+mn-lt"/>
                        </a:rPr>
                        <a:t> OR</a:t>
                      </a:r>
                      <a:endParaRPr lang="nl-NL" sz="800" b="1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p-value</a:t>
                      </a:r>
                      <a:endParaRPr lang="nl-NL" sz="800" b="1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3490190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+mn-lt"/>
                        </a:rPr>
                        <a:t>Male</a:t>
                      </a: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sex</a:t>
                      </a:r>
                      <a:endParaRPr lang="nl-NL" sz="8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1.34 (1.02 – 1.77)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&lt; 0.05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1.28 (0.96 – 1.73)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1.16 (0.86 – 1.57)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1.11 (0.82 – 1.52)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1946139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+mn-lt"/>
                        </a:rPr>
                        <a:t>Age (year)</a:t>
                      </a:r>
                      <a:endParaRPr lang="nl-NL" sz="8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01607421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    18 - 59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ref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-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ref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-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ref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-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ref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-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11004172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   60 – 69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4.34 (2.52 – 7.73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4.24 (2.45 – 7.63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  <a:endParaRPr lang="nl-NL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2.39 (1.16 – 5.30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5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2.56 (1.24 – 5.70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5</a:t>
                      </a:r>
                      <a:endParaRPr lang="nl-NL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3493488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   70 - 79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7.93 (4.87 – 13.59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7.40 (4.47 – 12.87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  <a:endParaRPr lang="nl-NL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4.89 (2.59 – 10.25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5.27 (2.76 – 11.14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6035940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   80 +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11.97 (7.30 – 20.65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12.19 (7.24 – 21.48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  <a:endParaRPr lang="nl-NL" sz="800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8.95 (4.8 – 18.55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9.61 (5.14 – 20.04)</a:t>
                      </a:r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nl-NL" sz="800" dirty="0" smtClean="0">
                          <a:solidFill>
                            <a:schemeClr val="tx1"/>
                          </a:solidFill>
                          <a:latin typeface="+mn-lt"/>
                        </a:rPr>
                        <a:t>&lt; 0.001</a:t>
                      </a: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1347274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solidFill>
                            <a:schemeClr val="tx1"/>
                          </a:solidFill>
                        </a:rPr>
                        <a:t>CCI per category </a:t>
                      </a:r>
                      <a:endParaRPr lang="nl-NL" sz="800" b="1" dirty="0">
                        <a:solidFill>
                          <a:schemeClr val="tx1"/>
                        </a:solidFill>
                        <a:latin typeface="Alwyn" panose="00000400000000000000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92327147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/>
                        <a:t>   0</a:t>
                      </a:r>
                      <a:endParaRPr lang="nl-NL" sz="800" dirty="0">
                        <a:latin typeface="Alwyn" panose="00000400000000000000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ref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-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ref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-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ref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-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ref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-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7448060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/>
                        <a:t>   1 or 2</a:t>
                      </a:r>
                      <a:endParaRPr lang="nl-NL" sz="800" dirty="0">
                        <a:latin typeface="Alwyn" panose="00000400000000000000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56 (1.14 – 2.13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&lt; 0.01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26 (0.90 – 1.76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83 (0.56 – 1.25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89 (0.60 – 1.36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9788154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/>
                        <a:t>   3 or 4</a:t>
                      </a:r>
                      <a:endParaRPr lang="nl-NL" sz="800" dirty="0">
                        <a:latin typeface="Alwyn" panose="00000400000000000000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2.43 (1.65 – 3.54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&lt; 0.001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55 (1.03 – 2.34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&lt;0.05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80 (0.51 – 1.26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67 (0.42 – 1.07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04022719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/>
                        <a:t>   5 or</a:t>
                      </a:r>
                      <a:r>
                        <a:rPr lang="en-US" sz="800" baseline="0" dirty="0" smtClean="0"/>
                        <a:t> more</a:t>
                      </a:r>
                      <a:endParaRPr lang="nl-NL" sz="800" dirty="0">
                        <a:latin typeface="Alwyn" panose="00000400000000000000" pitchFamily="2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2.24 (1.34 – 3.64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&lt; 0.01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43 (0.83 – 2.40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83 (0.49 – 1.39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68 (0.39 – 1.15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0013578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endParaRPr lang="nl-NL" sz="8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8059092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Virus</a:t>
                      </a:r>
                      <a:endParaRPr lang="nl-NL" sz="8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11907911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baseline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Influenza A</a:t>
                      </a:r>
                      <a:endParaRPr lang="nl-NL" sz="800" baseline="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f</a:t>
                      </a:r>
                      <a:endParaRPr lang="nl-NL" sz="8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nl-NL" sz="8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ref</a:t>
                      </a:r>
                      <a:endParaRPr lang="nl-NL" sz="8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-</a:t>
                      </a:r>
                      <a:endParaRPr lang="nl-NL" sz="8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766181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+mn-lt"/>
                        </a:rPr>
                        <a:t>   Influenza B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23 (0.79 – 1.90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07 (0.68 – 1.67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08196172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+mn-lt"/>
                        </a:rPr>
                        <a:t>   RSV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22 (0.74</a:t>
                      </a:r>
                      <a:r>
                        <a:rPr lang="nl-NL" sz="800" baseline="0" dirty="0" smtClean="0">
                          <a:latin typeface="+mn-lt"/>
                        </a:rPr>
                        <a:t> – 1.98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08 (0.65 – 1.77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9412352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b="1" dirty="0" smtClean="0">
                          <a:latin typeface="+mn-lt"/>
                        </a:rPr>
                        <a:t>   </a:t>
                      </a:r>
                      <a:r>
                        <a:rPr lang="en-US" sz="800" b="0" dirty="0" err="1" smtClean="0">
                          <a:latin typeface="+mn-lt"/>
                        </a:rPr>
                        <a:t>hMPV</a:t>
                      </a:r>
                      <a:endParaRPr lang="nl-NL" sz="800" b="1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07 (0.63 – 1.76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96 (0.56 – 1.60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5612588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b="0" dirty="0" smtClean="0">
                          <a:latin typeface="+mn-lt"/>
                        </a:rPr>
                        <a:t>   rhinovirus</a:t>
                      </a:r>
                      <a:endParaRPr lang="nl-NL" sz="800" b="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94 (0.62</a:t>
                      </a:r>
                      <a:r>
                        <a:rPr lang="nl-NL" sz="800" baseline="0" dirty="0" smtClean="0">
                          <a:latin typeface="+mn-lt"/>
                        </a:rPr>
                        <a:t> – 1.42)</a:t>
                      </a:r>
                      <a:endParaRPr lang="nl-NL" sz="800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1.03 (0.67 – 1.57)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ns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6566752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+mn-lt"/>
                        </a:rPr>
                        <a:t>   SARS-CoV-2 (March 2020 – Aug</a:t>
                      </a:r>
                      <a:r>
                        <a:rPr lang="en-US" sz="800" baseline="0" dirty="0" smtClean="0">
                          <a:latin typeface="+mn-lt"/>
                        </a:rPr>
                        <a:t> 2020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ref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-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+mn-lt"/>
                        </a:rPr>
                        <a:t>ref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-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2542335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+mn-lt"/>
                        </a:rPr>
                        <a:t>   SARS-CoV-2 (Sept 2020 – Feb</a:t>
                      </a:r>
                      <a:r>
                        <a:rPr lang="en-US" sz="800" baseline="0" dirty="0" smtClean="0">
                          <a:latin typeface="+mn-lt"/>
                        </a:rPr>
                        <a:t> 2021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79 (0.57 – 1.12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ns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55 (0.38 – 0.79)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+mn-lt"/>
                        </a:rPr>
                        <a:t>&lt; 0.01</a:t>
                      </a:r>
                      <a:endParaRPr lang="nl-NL" sz="800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6675058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dirty="0" smtClean="0">
                          <a:latin typeface="+mn-lt"/>
                        </a:rPr>
                        <a:t>   SARS-CoV-2 (March 2021 – Aug</a:t>
                      </a:r>
                      <a:r>
                        <a:rPr lang="en-US" sz="800" baseline="0" dirty="0" smtClean="0">
                          <a:latin typeface="+mn-lt"/>
                        </a:rPr>
                        <a:t> 2021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0.47 (0.31 – 0.71)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+mn-lt"/>
                        </a:rPr>
                        <a:t>&lt; 0.001</a:t>
                      </a:r>
                      <a:endParaRPr lang="nl-NL" sz="800" dirty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0.46 (0.29 – 0.71)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+mn-lt"/>
                        </a:rPr>
                        <a:t>&lt; 0.001</a:t>
                      </a:r>
                      <a:endParaRPr lang="nl-NL" sz="800" dirty="0" smtClean="0">
                        <a:latin typeface="+mn-lt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2368176"/>
                  </a:ext>
                </a:extLst>
              </a:tr>
              <a:tr h="239676">
                <a:tc>
                  <a:txBody>
                    <a:bodyPr/>
                    <a:lstStyle/>
                    <a:p>
                      <a:r>
                        <a:rPr lang="en-US" sz="800" baseline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  </a:t>
                      </a:r>
                      <a:r>
                        <a:rPr lang="en-US" sz="8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SARS-CoV-2 (Sept 2021 – Feb</a:t>
                      </a:r>
                      <a:r>
                        <a:rPr lang="en-US" sz="800" baseline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2022)</a:t>
                      </a:r>
                      <a:endParaRPr lang="nl-NL" sz="8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.48 (0.33 – 0.69)</a:t>
                      </a:r>
                      <a:endParaRPr lang="nl-NL" sz="8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nl-NL" sz="8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&lt; 0.001</a:t>
                      </a:r>
                      <a:endParaRPr lang="nl-NL" sz="80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0.34 (0.23 – 0.50)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&lt; 0.001</a:t>
                      </a:r>
                      <a:endParaRPr lang="nl-NL" sz="80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nl-NL" sz="8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Calibri" panose="020F0502020204030204" pitchFamily="34" charset="0"/>
                        </a:rPr>
                        <a:t>-</a:t>
                      </a:r>
                      <a:endParaRPr kumimoji="0" lang="nl-NL" sz="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Calibri" panose="020F050202020403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6443633"/>
                  </a:ext>
                </a:extLst>
              </a:tr>
            </a:tbl>
          </a:graphicData>
        </a:graphic>
      </p:graphicFrame>
      <p:sp>
        <p:nvSpPr>
          <p:cNvPr id="2" name="Rechthoek 1"/>
          <p:cNvSpPr/>
          <p:nvPr/>
        </p:nvSpPr>
        <p:spPr>
          <a:xfrm>
            <a:off x="144097" y="8038"/>
            <a:ext cx="1134599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nl-NL" sz="1600" b="1" dirty="0" err="1"/>
              <a:t>Table</a:t>
            </a:r>
            <a:r>
              <a:rPr lang="nl-NL" sz="1600" b="1" dirty="0"/>
              <a:t> </a:t>
            </a:r>
            <a:r>
              <a:rPr lang="nl-NL" sz="1600" b="1" dirty="0" smtClean="0"/>
              <a:t>S3.</a:t>
            </a:r>
            <a:r>
              <a:rPr lang="nl-NL" sz="1600" dirty="0" smtClean="0"/>
              <a:t> </a:t>
            </a:r>
            <a:r>
              <a:rPr lang="nl-NL" sz="1600" dirty="0" err="1" smtClean="0"/>
              <a:t>Multivariable</a:t>
            </a:r>
            <a:r>
              <a:rPr lang="nl-NL" sz="1600" dirty="0" smtClean="0"/>
              <a:t> </a:t>
            </a:r>
            <a:r>
              <a:rPr lang="nl-NL" sz="1600" dirty="0" err="1" smtClean="0"/>
              <a:t>regression</a:t>
            </a:r>
            <a:r>
              <a:rPr lang="nl-NL" sz="1600" dirty="0" smtClean="0"/>
              <a:t> </a:t>
            </a:r>
            <a:r>
              <a:rPr lang="nl-NL" sz="1600" dirty="0" err="1" smtClean="0"/>
              <a:t>models</a:t>
            </a:r>
            <a:r>
              <a:rPr lang="nl-NL" sz="1600" dirty="0" smtClean="0"/>
              <a:t> </a:t>
            </a:r>
            <a:r>
              <a:rPr lang="nl-NL" sz="1600" dirty="0" err="1" smtClean="0"/>
              <a:t>for</a:t>
            </a:r>
            <a:r>
              <a:rPr lang="nl-NL" sz="1600" dirty="0" smtClean="0"/>
              <a:t> 30-day </a:t>
            </a:r>
            <a:r>
              <a:rPr lang="nl-NL" sz="1600" dirty="0" err="1" smtClean="0"/>
              <a:t>mortality</a:t>
            </a:r>
            <a:r>
              <a:rPr lang="nl-NL" sz="1600" dirty="0" smtClean="0"/>
              <a:t> </a:t>
            </a:r>
            <a:r>
              <a:rPr lang="nl-NL" sz="1600" dirty="0" err="1"/>
              <a:t>for</a:t>
            </a:r>
            <a:r>
              <a:rPr lang="nl-NL" sz="1600" dirty="0"/>
              <a:t> </a:t>
            </a:r>
            <a:r>
              <a:rPr lang="nl-NL" sz="1600" dirty="0" smtClean="0"/>
              <a:t>SARS-CoV-2 per half </a:t>
            </a:r>
            <a:r>
              <a:rPr lang="nl-NL" sz="1600" dirty="0" err="1" smtClean="0"/>
              <a:t>year</a:t>
            </a:r>
            <a:r>
              <a:rPr lang="nl-NL" sz="1600" dirty="0"/>
              <a:t> </a:t>
            </a:r>
            <a:r>
              <a:rPr lang="nl-NL" sz="1600" dirty="0" err="1" smtClean="0"/>
              <a:t>and</a:t>
            </a:r>
            <a:r>
              <a:rPr lang="nl-NL" sz="1600" dirty="0" smtClean="0"/>
              <a:t> </a:t>
            </a:r>
            <a:r>
              <a:rPr lang="nl-NL" sz="1600" dirty="0" err="1" smtClean="0"/>
              <a:t>for</a:t>
            </a:r>
            <a:r>
              <a:rPr lang="nl-NL" sz="1600" dirty="0" smtClean="0"/>
              <a:t> </a:t>
            </a:r>
            <a:r>
              <a:rPr lang="nl-NL" sz="1600" dirty="0" err="1" smtClean="0"/>
              <a:t>other</a:t>
            </a:r>
            <a:r>
              <a:rPr lang="nl-NL" sz="1600" dirty="0" smtClean="0"/>
              <a:t> common </a:t>
            </a:r>
            <a:r>
              <a:rPr lang="nl-NL" sz="1600" dirty="0" err="1" smtClean="0"/>
              <a:t>respiratory</a:t>
            </a:r>
            <a:r>
              <a:rPr lang="nl-NL" sz="1600" dirty="0" smtClean="0"/>
              <a:t> </a:t>
            </a:r>
            <a:r>
              <a:rPr lang="nl-NL" sz="1600" dirty="0" err="1" smtClean="0"/>
              <a:t>viruses</a:t>
            </a:r>
            <a:r>
              <a:rPr lang="nl-NL" sz="1600" dirty="0" smtClean="0"/>
              <a:t>.</a:t>
            </a:r>
            <a:endParaRPr lang="nl-NL" sz="1600" dirty="0"/>
          </a:p>
        </p:txBody>
      </p:sp>
    </p:spTree>
    <p:extLst>
      <p:ext uri="{BB962C8B-B14F-4D97-AF65-F5344CB8AC3E}">
        <p14:creationId xmlns:p14="http://schemas.microsoft.com/office/powerpoint/2010/main" val="7767605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anto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695</Words>
  <Application>Microsoft Office PowerPoint</Application>
  <PresentationFormat>Breedbeeld</PresentationFormat>
  <Paragraphs>226</Paragraphs>
  <Slides>3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5</vt:i4>
      </vt:variant>
      <vt:variant>
        <vt:lpstr>Thema</vt:lpstr>
      </vt:variant>
      <vt:variant>
        <vt:i4>1</vt:i4>
      </vt:variant>
      <vt:variant>
        <vt:lpstr>Diatitels</vt:lpstr>
      </vt:variant>
      <vt:variant>
        <vt:i4>3</vt:i4>
      </vt:variant>
    </vt:vector>
  </HeadingPairs>
  <TitlesOfParts>
    <vt:vector size="9" baseType="lpstr">
      <vt:lpstr>Alwyn</vt:lpstr>
      <vt:lpstr>Arial</vt:lpstr>
      <vt:lpstr>Calibri</vt:lpstr>
      <vt:lpstr>Calibri Light</vt:lpstr>
      <vt:lpstr>Times New Roman</vt:lpstr>
      <vt:lpstr>Kantoorthema</vt:lpstr>
      <vt:lpstr>PowerPoint-presentatie</vt:lpstr>
      <vt:lpstr>PowerPoint-presentatie</vt:lpstr>
      <vt:lpstr>PowerPoint-presentatie</vt:lpstr>
    </vt:vector>
  </TitlesOfParts>
  <Company>St. Antonius Ziekenhu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Boon, Hanneke (MMI)</dc:creator>
  <cp:lastModifiedBy>Boon, Hanneke (MMI)</cp:lastModifiedBy>
  <cp:revision>3</cp:revision>
  <dcterms:created xsi:type="dcterms:W3CDTF">2023-11-28T08:30:08Z</dcterms:created>
  <dcterms:modified xsi:type="dcterms:W3CDTF">2023-11-28T08:59:00Z</dcterms:modified>
</cp:coreProperties>
</file>